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2" r:id="rId3"/>
    <p:sldId id="259" r:id="rId4"/>
    <p:sldId id="260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88" d="100"/>
          <a:sy n="88" d="100"/>
        </p:scale>
        <p:origin x="132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99151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0709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021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7547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8995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6508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4810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586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7572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9769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0974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1BA23-2228-4037-B91D-E5708AE9A9D5}" type="datetimeFigureOut">
              <a:rPr lang="ko-KR" altLang="en-US" smtClean="0"/>
              <a:t>2021-10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473C91-7D08-430A-A165-2BA831F172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5482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microsoft.com/office/2007/relationships/hdphoto" Target="../media/hdphoto1.wdp"/><Relationship Id="rId7" Type="http://schemas.openxmlformats.org/officeDocument/2006/relationships/image" Target="../media/image5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image" Target="../media/image18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12" Type="http://schemas.openxmlformats.org/officeDocument/2006/relationships/image" Target="../media/image17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11" Type="http://schemas.openxmlformats.org/officeDocument/2006/relationships/image" Target="../media/image16.jpeg"/><Relationship Id="rId5" Type="http://schemas.openxmlformats.org/officeDocument/2006/relationships/image" Target="../media/image10.jpeg"/><Relationship Id="rId10" Type="http://schemas.openxmlformats.org/officeDocument/2006/relationships/image" Target="../media/image15.jpe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tiff"/><Relationship Id="rId5" Type="http://schemas.openxmlformats.org/officeDocument/2006/relationships/image" Target="../media/image21.tiff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0" y="0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Figure 1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919592" y="2158593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595" t="23400" r="42993" b="13004"/>
          <a:stretch/>
        </p:blipFill>
        <p:spPr>
          <a:xfrm>
            <a:off x="1274219" y="2977471"/>
            <a:ext cx="1246909" cy="86452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8" name="그림 1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72" t="13439" r="46667" b="31225"/>
          <a:stretch/>
        </p:blipFill>
        <p:spPr>
          <a:xfrm>
            <a:off x="1274218" y="3902401"/>
            <a:ext cx="1246909" cy="23750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19" name="그림 1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81" t="9006" r="45613" b="29061"/>
          <a:stretch/>
        </p:blipFill>
        <p:spPr>
          <a:xfrm>
            <a:off x="2554827" y="3898680"/>
            <a:ext cx="1263535" cy="23750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20" name="그림 1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40" t="11919" r="42016" b="9293"/>
          <a:stretch/>
        </p:blipFill>
        <p:spPr>
          <a:xfrm>
            <a:off x="2554828" y="2977471"/>
            <a:ext cx="1263535" cy="86452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21" name="TextBox 20"/>
          <p:cNvSpPr txBox="1"/>
          <p:nvPr/>
        </p:nvSpPr>
        <p:spPr>
          <a:xfrm>
            <a:off x="903323" y="2968933"/>
            <a:ext cx="438005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240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3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743931" y="3225066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TD110.6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742966" y="3898680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직선 연결선 23"/>
          <p:cNvCxnSpPr/>
          <p:nvPr/>
        </p:nvCxnSpPr>
        <p:spPr>
          <a:xfrm>
            <a:off x="1284096" y="2696264"/>
            <a:ext cx="122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/>
          <p:cNvCxnSpPr/>
          <p:nvPr/>
        </p:nvCxnSpPr>
        <p:spPr>
          <a:xfrm>
            <a:off x="2554827" y="2696264"/>
            <a:ext cx="12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1649874" y="2433943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868073" y="2433904"/>
            <a:ext cx="6335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</a:t>
            </a:r>
            <a:r>
              <a:rPr lang="en-US" altLang="ko-KR" sz="9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ko-KR" alt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209406" y="2711489"/>
            <a:ext cx="30059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      3      6      9     12       0      3      6      9     12   (</a:t>
            </a:r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03323" y="2824802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그림 45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2" t="-91" r="-287" b="157"/>
          <a:stretch/>
        </p:blipFill>
        <p:spPr>
          <a:xfrm>
            <a:off x="5850259" y="522654"/>
            <a:ext cx="4825386" cy="3613532"/>
          </a:xfrm>
          <a:prstGeom prst="rect">
            <a:avLst/>
          </a:prstGeom>
        </p:spPr>
      </p:pic>
      <p:pic>
        <p:nvPicPr>
          <p:cNvPr id="47" name="그림 46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23" t="-326" r="52" b="34219"/>
          <a:stretch/>
        </p:blipFill>
        <p:spPr>
          <a:xfrm>
            <a:off x="5818989" y="4208484"/>
            <a:ext cx="4858438" cy="2390660"/>
          </a:xfrm>
          <a:prstGeom prst="rect">
            <a:avLst/>
          </a:prstGeom>
        </p:spPr>
      </p:pic>
      <p:sp>
        <p:nvSpPr>
          <p:cNvPr id="48" name="오른쪽 대괄호 47"/>
          <p:cNvSpPr/>
          <p:nvPr/>
        </p:nvSpPr>
        <p:spPr>
          <a:xfrm rot="16200000">
            <a:off x="7763223" y="1723084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927052" y="1987649"/>
            <a:ext cx="19383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-GlcNAc (</a:t>
            </a:r>
            <a:r>
              <a:rPr lang="en-US" altLang="ko-KR" sz="1000" b="1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D110.6</a:t>
            </a:r>
            <a:r>
              <a:rPr lang="en-US" sz="1000" b="1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Stx2a</a:t>
            </a:r>
            <a:endParaRPr lang="en-US" sz="10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오른쪽 대괄호 49"/>
          <p:cNvSpPr/>
          <p:nvPr/>
        </p:nvSpPr>
        <p:spPr>
          <a:xfrm rot="16200000">
            <a:off x="7788314" y="331188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6873599" y="595753"/>
            <a:ext cx="2095445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b="1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-GlcNAc (CTD110.6) </a:t>
            </a:r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Stx2a</a:t>
            </a:r>
            <a:r>
              <a:rPr lang="en-US" sz="1000" b="1" baseline="30000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000" b="1" baseline="300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오른쪽 대괄호 51"/>
          <p:cNvSpPr/>
          <p:nvPr/>
        </p:nvSpPr>
        <p:spPr>
          <a:xfrm rot="16200000">
            <a:off x="7654340" y="5128613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7262201" y="5393178"/>
            <a:ext cx="10502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000" b="1" dirty="0">
                <a:solidFill>
                  <a:srgbClr val="FFFF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sz="10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 Stx2a</a:t>
            </a:r>
            <a:endParaRPr lang="en-US" sz="10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오른쪽 대괄호 53"/>
          <p:cNvSpPr/>
          <p:nvPr/>
        </p:nvSpPr>
        <p:spPr>
          <a:xfrm rot="16200000">
            <a:off x="7679431" y="4259232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208747" y="4523797"/>
            <a:ext cx="1207382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l-GR" sz="1000" b="1" dirty="0" smtClean="0">
                <a:solidFill>
                  <a:srgbClr val="FFFF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sz="10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Stx2a</a:t>
            </a:r>
            <a:r>
              <a:rPr lang="en-US" sz="1000" b="1" baseline="30000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</a:t>
            </a:r>
            <a:endParaRPr lang="en-US" sz="1000" b="1" baseline="300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377950" y="1625365"/>
            <a:ext cx="4956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72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377950" y="1398350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93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6317036" y="1181208"/>
            <a:ext cx="5565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125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377950" y="3074381"/>
            <a:ext cx="4956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72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6377950" y="2847366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93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6317036" y="2630224"/>
            <a:ext cx="5565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125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185048" y="4920576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srgbClr val="FFFF00"/>
                </a:solidFill>
              </a:rPr>
              <a:t>4</a:t>
            </a:r>
            <a:r>
              <a:rPr lang="en-US" sz="1050" b="1" dirty="0" smtClean="0">
                <a:solidFill>
                  <a:srgbClr val="FFFF00"/>
                </a:solidFill>
              </a:rPr>
              <a:t>2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6193889" y="5705196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srgbClr val="FFFF00"/>
                </a:solidFill>
              </a:rPr>
              <a:t>4</a:t>
            </a:r>
            <a:r>
              <a:rPr lang="en-US" sz="1050" b="1" dirty="0" smtClean="0">
                <a:solidFill>
                  <a:srgbClr val="FFFF00"/>
                </a:solidFill>
              </a:rPr>
              <a:t>2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099886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71" t="39410" r="36471" b="35832"/>
          <a:stretch/>
        </p:blipFill>
        <p:spPr>
          <a:xfrm>
            <a:off x="4360445" y="3758329"/>
            <a:ext cx="1767119" cy="1020663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52" t="34117" r="31402" b="39726"/>
          <a:stretch/>
        </p:blipFill>
        <p:spPr>
          <a:xfrm>
            <a:off x="9476160" y="2237798"/>
            <a:ext cx="2057400" cy="1047750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51" t="17115" r="32605" b="30136"/>
          <a:stretch/>
        </p:blipFill>
        <p:spPr>
          <a:xfrm>
            <a:off x="4689109" y="5078564"/>
            <a:ext cx="1320801" cy="1540933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92" t="38224" r="15941" b="25113"/>
          <a:stretch/>
        </p:blipFill>
        <p:spPr>
          <a:xfrm>
            <a:off x="9406872" y="3757990"/>
            <a:ext cx="2498952" cy="107530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16" t="40914" r="33255" b="32095"/>
          <a:stretch/>
        </p:blipFill>
        <p:spPr>
          <a:xfrm>
            <a:off x="7004293" y="3682969"/>
            <a:ext cx="1840527" cy="1150329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89" t="27064" r="27492" b="28689"/>
          <a:stretch/>
        </p:blipFill>
        <p:spPr>
          <a:xfrm>
            <a:off x="7108999" y="2071985"/>
            <a:ext cx="1600200" cy="1360523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03" t="34756" r="26958" b="26641"/>
          <a:stretch/>
        </p:blipFill>
        <p:spPr>
          <a:xfrm>
            <a:off x="4376109" y="2070314"/>
            <a:ext cx="1947335" cy="1354667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51" t="22663" r="37639" b="24490"/>
          <a:stretch/>
        </p:blipFill>
        <p:spPr>
          <a:xfrm>
            <a:off x="9668407" y="343923"/>
            <a:ext cx="1617133" cy="1540934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11" t="27655" r="35072" b="32929"/>
          <a:stretch/>
        </p:blipFill>
        <p:spPr>
          <a:xfrm>
            <a:off x="7094270" y="605310"/>
            <a:ext cx="1600200" cy="1303868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15" t="28993" r="24075" b="25985"/>
          <a:stretch/>
        </p:blipFill>
        <p:spPr>
          <a:xfrm>
            <a:off x="4439616" y="552853"/>
            <a:ext cx="1800596" cy="1228642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5065359" y="220813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오른쪽 대괄호 14"/>
          <p:cNvSpPr/>
          <p:nvPr/>
        </p:nvSpPr>
        <p:spPr>
          <a:xfrm rot="16200000">
            <a:off x="5128996" y="368489"/>
            <a:ext cx="513593" cy="71429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7709658" y="243012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오른쪽 대괄호 16"/>
          <p:cNvSpPr/>
          <p:nvPr/>
        </p:nvSpPr>
        <p:spPr>
          <a:xfrm rot="16200000">
            <a:off x="7678396" y="346717"/>
            <a:ext cx="510469" cy="857698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10232129" y="0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Grp7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오른쪽 대괄호 18"/>
          <p:cNvSpPr/>
          <p:nvPr/>
        </p:nvSpPr>
        <p:spPr>
          <a:xfrm rot="16200000">
            <a:off x="10092291" y="270382"/>
            <a:ext cx="802598" cy="74785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5069911" y="1825136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p-IRE1</a:t>
            </a:r>
            <a:r>
              <a:rPr lang="el-GR" sz="1000" b="1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오른쪽 대괄호 20"/>
          <p:cNvSpPr/>
          <p:nvPr/>
        </p:nvSpPr>
        <p:spPr>
          <a:xfrm rot="16200000">
            <a:off x="5129986" y="1899554"/>
            <a:ext cx="563490" cy="821929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7610327" y="1917299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IRE1</a:t>
            </a:r>
            <a:r>
              <a:rPr lang="el-GR" sz="1000" b="1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오른쪽 대괄호 22"/>
          <p:cNvSpPr/>
          <p:nvPr/>
        </p:nvSpPr>
        <p:spPr>
          <a:xfrm rot="16200000">
            <a:off x="7684993" y="1955643"/>
            <a:ext cx="397005" cy="73339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>
            <a:off x="10428464" y="1909178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XBP1s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오른쪽 대괄호 24"/>
          <p:cNvSpPr/>
          <p:nvPr/>
        </p:nvSpPr>
        <p:spPr>
          <a:xfrm rot="16200000">
            <a:off x="10591053" y="1767708"/>
            <a:ext cx="263446" cy="98128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/>
          <p:cNvSpPr txBox="1"/>
          <p:nvPr/>
        </p:nvSpPr>
        <p:spPr>
          <a:xfrm>
            <a:off x="5019598" y="3482881"/>
            <a:ext cx="6429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GFAT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오른쪽 대괄호 26"/>
          <p:cNvSpPr/>
          <p:nvPr/>
        </p:nvSpPr>
        <p:spPr>
          <a:xfrm rot="16200000">
            <a:off x="5116020" y="3383855"/>
            <a:ext cx="415378" cy="108665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7629113" y="3511769"/>
            <a:ext cx="5633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OGT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오른쪽 대괄호 28"/>
          <p:cNvSpPr/>
          <p:nvPr/>
        </p:nvSpPr>
        <p:spPr>
          <a:xfrm rot="16200000">
            <a:off x="7779726" y="3452432"/>
            <a:ext cx="428931" cy="97881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/>
          <p:cNvSpPr txBox="1"/>
          <p:nvPr/>
        </p:nvSpPr>
        <p:spPr>
          <a:xfrm>
            <a:off x="10043578" y="3445180"/>
            <a:ext cx="12255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O-GlcNAc (RL2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오른쪽 대괄호 30"/>
          <p:cNvSpPr/>
          <p:nvPr/>
        </p:nvSpPr>
        <p:spPr>
          <a:xfrm rot="16200000">
            <a:off x="10522247" y="3247369"/>
            <a:ext cx="277753" cy="1104587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5067938" y="4895300"/>
            <a:ext cx="6551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오른쪽 대괄호 32"/>
          <p:cNvSpPr/>
          <p:nvPr/>
        </p:nvSpPr>
        <p:spPr>
          <a:xfrm rot="16200000">
            <a:off x="5092227" y="4978906"/>
            <a:ext cx="514566" cy="852512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3961747" y="893173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961747" y="1045609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975485" y="64466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6565838" y="910107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565838" y="102867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579576" y="644667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9240999" y="880769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9240999" y="999337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9197030" y="69999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970606" y="2523076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028313" y="2641644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984344" y="2308438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522203" y="2420047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579910" y="2538615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6535941" y="2205409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9284968" y="2330330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9284968" y="2587051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9240999" y="217813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097874" y="4037739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097874" y="4225786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053905" y="3823101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6634337" y="4080402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692044" y="4198970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648075" y="3831896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9313106" y="4157870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9269137" y="3790796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9313106" y="4071133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9257405" y="3979930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333562" y="5536203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4289593" y="5262296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333293" y="5657071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465406" y="3064742"/>
            <a:ext cx="8579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n-specific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오른쪽 대괄호 65"/>
          <p:cNvSpPr/>
          <p:nvPr/>
        </p:nvSpPr>
        <p:spPr>
          <a:xfrm rot="5400000">
            <a:off x="7777212" y="2603397"/>
            <a:ext cx="206475" cy="73948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8" name="그림 67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66" t="48829" r="38415" b="47360"/>
          <a:stretch/>
        </p:blipFill>
        <p:spPr>
          <a:xfrm>
            <a:off x="925444" y="2562051"/>
            <a:ext cx="1674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9" name="TextBox 68"/>
          <p:cNvSpPr txBox="1"/>
          <p:nvPr/>
        </p:nvSpPr>
        <p:spPr>
          <a:xfrm>
            <a:off x="369316" y="1380644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38300" y="1752367"/>
            <a:ext cx="22990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MI-1: 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-     - 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-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­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85243" y="1966563"/>
            <a:ext cx="23984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KC-3946: 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  - 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-     - 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38275" y="2190815"/>
            <a:ext cx="21611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:    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  -     - 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 ­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그림 72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17" t="41600" r="41654" b="51461"/>
          <a:stretch/>
        </p:blipFill>
        <p:spPr>
          <a:xfrm>
            <a:off x="925444" y="2824659"/>
            <a:ext cx="1674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그림 73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47" t="47079" r="47847" b="46823"/>
          <a:stretch/>
        </p:blipFill>
        <p:spPr>
          <a:xfrm>
            <a:off x="930356" y="3082467"/>
            <a:ext cx="1674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그림 74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84" t="51142" r="37747" b="44998"/>
          <a:stretch/>
        </p:blipFill>
        <p:spPr>
          <a:xfrm>
            <a:off x="925444" y="3352779"/>
            <a:ext cx="1674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그림 75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04" t="42561" r="37507" b="52207"/>
          <a:stretch/>
        </p:blipFill>
        <p:spPr>
          <a:xfrm>
            <a:off x="925444" y="3607945"/>
            <a:ext cx="1674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그림 77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39" t="52721" r="38436" b="41120"/>
          <a:stretch/>
        </p:blipFill>
        <p:spPr>
          <a:xfrm>
            <a:off x="925444" y="4381585"/>
            <a:ext cx="1674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9" name="그림 78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77" t="43712" r="33033" b="31462"/>
          <a:stretch/>
        </p:blipFill>
        <p:spPr>
          <a:xfrm>
            <a:off x="925444" y="4647844"/>
            <a:ext cx="1674000" cy="4752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0" name="그림 79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61" t="35349" r="39288" b="56536"/>
          <a:stretch/>
        </p:blipFill>
        <p:spPr>
          <a:xfrm>
            <a:off x="925444" y="5190266"/>
            <a:ext cx="1674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1" name="TextBox 80"/>
          <p:cNvSpPr txBox="1"/>
          <p:nvPr/>
        </p:nvSpPr>
        <p:spPr>
          <a:xfrm>
            <a:off x="2625221" y="5171440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2637327" y="2552188"/>
            <a:ext cx="6142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2633600" y="2810043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638742" y="3060081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rp78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628433" y="3332568"/>
            <a:ext cx="62068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IRE1</a:t>
            </a:r>
            <a:r>
              <a:rPr lang="el-GR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2637182" y="3586986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IRE1</a:t>
            </a:r>
            <a:r>
              <a:rPr lang="el-GR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631496" y="4111825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GFAT1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2629627" y="3845227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XBP1s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633191" y="4364340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OGT</a:t>
            </a:r>
            <a:endParaRPr lang="ko-KR" altLang="en-US" sz="9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637096" y="4698640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81770" y="2434447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81770" y="2697967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90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540384" y="2994166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82677" y="324973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81770" y="3504312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40415" y="3866210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40415" y="3994806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altLang="ko-KR" sz="8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900" b="1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83615" y="426690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15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83615" y="4570183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540416" y="4737294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539508" y="5088928"/>
            <a:ext cx="3834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241732" y="2492164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0" y="0"/>
            <a:ext cx="1235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Figure </a:t>
            </a:r>
            <a:r>
              <a:rPr lang="en-US" altLang="ko-KR" b="1" dirty="0" smtClean="0"/>
              <a:t>1C</a:t>
            </a:r>
            <a:endParaRPr lang="en-US" altLang="ko-KR" b="1" dirty="0" smtClean="0"/>
          </a:p>
        </p:txBody>
      </p:sp>
      <p:pic>
        <p:nvPicPr>
          <p:cNvPr id="3" name="그림 2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51" t="42349" r="37645" b="51492"/>
          <a:stretch/>
        </p:blipFill>
        <p:spPr>
          <a:xfrm>
            <a:off x="923001" y="3865731"/>
            <a:ext cx="1674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8" name="그림 107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51" t="49888" r="40413" b="43350"/>
          <a:stretch/>
        </p:blipFill>
        <p:spPr>
          <a:xfrm>
            <a:off x="917614" y="4124986"/>
            <a:ext cx="1674000" cy="20160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9146450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Figure 1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28" t="6833" r="2175" b="6390"/>
          <a:stretch/>
        </p:blipFill>
        <p:spPr>
          <a:xfrm>
            <a:off x="517233" y="3625212"/>
            <a:ext cx="2748141" cy="169382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474" t="30803" r="957" b="30555"/>
          <a:stretch/>
        </p:blipFill>
        <p:spPr>
          <a:xfrm>
            <a:off x="517233" y="5362588"/>
            <a:ext cx="2748141" cy="19469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97" t="23783" b="6866"/>
          <a:stretch/>
        </p:blipFill>
        <p:spPr>
          <a:xfrm>
            <a:off x="517233" y="2073439"/>
            <a:ext cx="2748141" cy="73983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47" t="14677" r="697" b="11733"/>
          <a:stretch/>
        </p:blipFill>
        <p:spPr>
          <a:xfrm>
            <a:off x="517233" y="2866764"/>
            <a:ext cx="2748141" cy="71489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87700" y="1209949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46338" y="2022506"/>
            <a:ext cx="438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21441" y="5339606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직선 연결선 9"/>
          <p:cNvCxnSpPr/>
          <p:nvPr/>
        </p:nvCxnSpPr>
        <p:spPr>
          <a:xfrm>
            <a:off x="528514" y="1815653"/>
            <a:ext cx="13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연결선 10"/>
          <p:cNvCxnSpPr/>
          <p:nvPr/>
        </p:nvCxnSpPr>
        <p:spPr>
          <a:xfrm>
            <a:off x="1918914" y="1815653"/>
            <a:ext cx="13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527973" y="1585593"/>
            <a:ext cx="14093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(Vehicle only)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867410" y="1585593"/>
            <a:ext cx="14350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GT inhibitor (OSMI-1)</a:t>
            </a:r>
            <a:endParaRPr lang="ko-KR" alt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95389" y="1830878"/>
            <a:ext cx="31341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       3       6       9     12      0       3       6       9     12   (</a:t>
            </a:r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46338" y="187837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직선 연결선 15"/>
          <p:cNvCxnSpPr/>
          <p:nvPr/>
        </p:nvCxnSpPr>
        <p:spPr>
          <a:xfrm>
            <a:off x="527973" y="1571587"/>
            <a:ext cx="27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645081" y="1341720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65033" y="523305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46338" y="2777935"/>
            <a:ext cx="438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83734" y="3766883"/>
            <a:ext cx="394723" cy="1154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9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pPr algn="r"/>
            <a:endParaRPr lang="en-US" altLang="ko-KR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197023" y="3045319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197023" y="3625719"/>
            <a:ext cx="761747" cy="11849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-</a:t>
            </a: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</a:p>
          <a:p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9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</a:p>
          <a:p>
            <a:endParaRPr lang="en-US" altLang="ko-KR" sz="5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endParaRPr lang="en-US" altLang="ko-K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5400000">
            <a:off x="3076374" y="4522582"/>
            <a:ext cx="12362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leaved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오른쪽 대괄호 23"/>
          <p:cNvSpPr/>
          <p:nvPr/>
        </p:nvSpPr>
        <p:spPr>
          <a:xfrm>
            <a:off x="3555149" y="4473980"/>
            <a:ext cx="45719" cy="252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3" name="그림 5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88" t="-97" r="242" b="25060"/>
          <a:stretch/>
        </p:blipFill>
        <p:spPr bwMode="invGray">
          <a:xfrm>
            <a:off x="5884018" y="428001"/>
            <a:ext cx="4836975" cy="3073489"/>
          </a:xfrm>
          <a:prstGeom prst="rect">
            <a:avLst/>
          </a:prstGeom>
        </p:spPr>
      </p:pic>
      <p:sp>
        <p:nvSpPr>
          <p:cNvPr id="54" name="오른쪽 대괄호 53"/>
          <p:cNvSpPr/>
          <p:nvPr/>
        </p:nvSpPr>
        <p:spPr>
          <a:xfrm rot="16200000">
            <a:off x="7371998" y="-54810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TextBox 54"/>
          <p:cNvSpPr txBox="1"/>
          <p:nvPr/>
        </p:nvSpPr>
        <p:spPr>
          <a:xfrm>
            <a:off x="6758644" y="66921"/>
            <a:ext cx="14927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CTD110.6)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vehicl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오른쪽 대괄호 55"/>
          <p:cNvSpPr/>
          <p:nvPr/>
        </p:nvSpPr>
        <p:spPr>
          <a:xfrm rot="16200000">
            <a:off x="8710064" y="-54810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56"/>
          <p:cNvSpPr txBox="1"/>
          <p:nvPr/>
        </p:nvSpPr>
        <p:spPr>
          <a:xfrm>
            <a:off x="8096710" y="52830"/>
            <a:ext cx="14927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CTD110.6)</a:t>
            </a:r>
          </a:p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/ OSMI-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오른쪽 대괄호 57"/>
          <p:cNvSpPr/>
          <p:nvPr/>
        </p:nvSpPr>
        <p:spPr>
          <a:xfrm rot="16200000">
            <a:off x="7305496" y="1476505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TextBox 58"/>
          <p:cNvSpPr txBox="1"/>
          <p:nvPr/>
        </p:nvSpPr>
        <p:spPr>
          <a:xfrm>
            <a:off x="6840420" y="1598236"/>
            <a:ext cx="11961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RL-2)</a:t>
            </a:r>
          </a:p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vehicle</a:t>
            </a:r>
            <a:endParaRPr lang="en-US" sz="10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오른쪽 대괄호 59"/>
          <p:cNvSpPr/>
          <p:nvPr/>
        </p:nvSpPr>
        <p:spPr>
          <a:xfrm rot="16200000">
            <a:off x="8693440" y="1476505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TextBox 60"/>
          <p:cNvSpPr txBox="1"/>
          <p:nvPr/>
        </p:nvSpPr>
        <p:spPr>
          <a:xfrm>
            <a:off x="8228364" y="1584145"/>
            <a:ext cx="11961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sz="1000" b="1" dirty="0" err="1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RL-2)</a:t>
            </a:r>
          </a:p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OSMI-1</a:t>
            </a:r>
            <a:endParaRPr lang="en-US" sz="10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813369" y="1428798"/>
            <a:ext cx="4956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72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813369" y="1168531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93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752455" y="918137"/>
            <a:ext cx="5565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125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813369" y="2819623"/>
            <a:ext cx="4956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72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5813369" y="2559356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93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752455" y="2308963"/>
            <a:ext cx="5565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>
                <a:solidFill>
                  <a:srgbClr val="FFFF00"/>
                </a:solidFill>
              </a:rPr>
              <a:t>125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pic>
        <p:nvPicPr>
          <p:cNvPr id="68" name="그림 67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36" t="6935" r="4215" b="16690"/>
          <a:stretch/>
        </p:blipFill>
        <p:spPr bwMode="invGray">
          <a:xfrm>
            <a:off x="5945242" y="3770158"/>
            <a:ext cx="4582886" cy="2928257"/>
          </a:xfrm>
          <a:prstGeom prst="rect">
            <a:avLst/>
          </a:prstGeom>
        </p:spPr>
      </p:pic>
      <p:sp>
        <p:nvSpPr>
          <p:cNvPr id="69" name="오른쪽 대괄호 68"/>
          <p:cNvSpPr/>
          <p:nvPr/>
        </p:nvSpPr>
        <p:spPr>
          <a:xfrm rot="16200000">
            <a:off x="7132304" y="3770593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6853978" y="3892324"/>
            <a:ext cx="822661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</a:p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vehicle</a:t>
            </a:r>
            <a:endParaRPr lang="en-US" sz="10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오른쪽 대괄호 70"/>
          <p:cNvSpPr/>
          <p:nvPr/>
        </p:nvSpPr>
        <p:spPr>
          <a:xfrm rot="16200000">
            <a:off x="8470370" y="3770593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8192044" y="3878233"/>
            <a:ext cx="822661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</a:p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OSMI-1</a:t>
            </a:r>
            <a:endParaRPr lang="en-US" sz="10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697417" y="5484350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18</a:t>
            </a:r>
            <a:r>
              <a:rPr lang="en-US" sz="1050" b="1" dirty="0" smtClean="0">
                <a:solidFill>
                  <a:srgbClr val="FFFF00"/>
                </a:solidFill>
              </a:rPr>
              <a:t>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5707709" y="4930756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24</a:t>
            </a:r>
            <a:r>
              <a:rPr lang="en-US" sz="1050" b="1" dirty="0" smtClean="0">
                <a:solidFill>
                  <a:srgbClr val="FFFF00"/>
                </a:solidFill>
              </a:rPr>
              <a:t>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705432" y="4631078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31</a:t>
            </a:r>
            <a:r>
              <a:rPr lang="en-US" sz="1050" b="1" dirty="0" smtClean="0">
                <a:solidFill>
                  <a:srgbClr val="FFFF00"/>
                </a:solidFill>
              </a:rPr>
              <a:t>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12504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Figure 1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그림 2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5" t="16194" r="6637" b="9607"/>
          <a:stretch/>
        </p:blipFill>
        <p:spPr bwMode="invGray">
          <a:xfrm>
            <a:off x="5675086" y="1573441"/>
            <a:ext cx="5301343" cy="2906485"/>
          </a:xfrm>
          <a:prstGeom prst="rect">
            <a:avLst/>
          </a:prstGeom>
        </p:spPr>
      </p:pic>
      <p:sp>
        <p:nvSpPr>
          <p:cNvPr id="26" name="오른쪽 대괄호 25"/>
          <p:cNvSpPr/>
          <p:nvPr/>
        </p:nvSpPr>
        <p:spPr>
          <a:xfrm rot="16200000">
            <a:off x="7312595" y="2780920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084763" y="2902651"/>
            <a:ext cx="721672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l-GR" sz="1000" b="1" dirty="0" smtClean="0">
                <a:solidFill>
                  <a:srgbClr val="FFFF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vehicle</a:t>
            </a:r>
            <a:endParaRPr lang="en-US" sz="10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오른쪽 대괄호 27"/>
          <p:cNvSpPr/>
          <p:nvPr/>
        </p:nvSpPr>
        <p:spPr>
          <a:xfrm rot="16200000">
            <a:off x="8650661" y="2780920"/>
            <a:ext cx="266008" cy="1287581"/>
          </a:xfrm>
          <a:prstGeom prst="rightBracket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8418020" y="2888560"/>
            <a:ext cx="731290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l-GR" sz="1000" b="1" dirty="0" smtClean="0">
                <a:solidFill>
                  <a:srgbClr val="FFFF00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β</a:t>
            </a:r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  <a:p>
            <a:pPr algn="ctr"/>
            <a:r>
              <a:rPr lang="en-US" sz="1000" b="1" dirty="0" smtClean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/ OSMI-1</a:t>
            </a:r>
            <a:endParaRPr lang="en-US" sz="10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813967" y="3399771"/>
            <a:ext cx="4876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solidFill>
                  <a:srgbClr val="FFFF00"/>
                </a:solidFill>
              </a:rPr>
              <a:t>4</a:t>
            </a:r>
            <a:r>
              <a:rPr lang="en-US" sz="1050" b="1" dirty="0" smtClean="0">
                <a:solidFill>
                  <a:srgbClr val="FFFF00"/>
                </a:solidFill>
              </a:rPr>
              <a:t>2 </a:t>
            </a:r>
            <a:r>
              <a:rPr lang="en-US" sz="1050" b="1" dirty="0" smtClean="0">
                <a:solidFill>
                  <a:srgbClr val="FFFF00"/>
                </a:solidFill>
                <a:latin typeface="맑은 고딕" panose="020B0503020000020004" pitchFamily="50" charset="-127"/>
                <a:ea typeface="맑은 고딕" panose="020B0503020000020004" pitchFamily="50" charset="-127"/>
              </a:rPr>
              <a:t>→</a:t>
            </a:r>
            <a:endParaRPr lang="en-US" sz="1050" b="1" dirty="0">
              <a:solidFill>
                <a:srgbClr val="FFFF00"/>
              </a:solidFill>
            </a:endParaRPr>
          </a:p>
        </p:txBody>
      </p:sp>
      <p:pic>
        <p:nvPicPr>
          <p:cNvPr id="31" name="그림 3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28" t="6833" r="2175" b="6390"/>
          <a:stretch/>
        </p:blipFill>
        <p:spPr>
          <a:xfrm>
            <a:off x="517233" y="3625212"/>
            <a:ext cx="2748141" cy="169382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2" name="그림 31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474" t="30803" r="957" b="30555"/>
          <a:stretch/>
        </p:blipFill>
        <p:spPr>
          <a:xfrm>
            <a:off x="517233" y="5362588"/>
            <a:ext cx="2748141" cy="19469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3" name="그림 3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97" t="23783" b="6866"/>
          <a:stretch/>
        </p:blipFill>
        <p:spPr>
          <a:xfrm>
            <a:off x="517233" y="2073439"/>
            <a:ext cx="2748141" cy="739833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4" name="그림 3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47" t="14677" r="697" b="11733"/>
          <a:stretch/>
        </p:blipFill>
        <p:spPr>
          <a:xfrm>
            <a:off x="517233" y="2866764"/>
            <a:ext cx="2748141" cy="71489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5" name="TextBox 34"/>
          <p:cNvSpPr txBox="1"/>
          <p:nvPr/>
        </p:nvSpPr>
        <p:spPr>
          <a:xfrm>
            <a:off x="87700" y="1209949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46338" y="2022506"/>
            <a:ext cx="438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221441" y="5339606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직선 연결선 37"/>
          <p:cNvCxnSpPr/>
          <p:nvPr/>
        </p:nvCxnSpPr>
        <p:spPr>
          <a:xfrm>
            <a:off x="528514" y="1815653"/>
            <a:ext cx="13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>
            <a:off x="1918914" y="1815653"/>
            <a:ext cx="13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527973" y="1585593"/>
            <a:ext cx="14093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(Vehicle only)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867410" y="1585593"/>
            <a:ext cx="14350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GT inhibitor (OSMI-1)</a:t>
            </a:r>
            <a:endParaRPr lang="ko-KR" altLang="en-US" sz="9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95389" y="1830878"/>
            <a:ext cx="31341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0       3       6       9     12      0       3       6       9     12   (</a:t>
            </a:r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46338" y="1878375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>
            <a:off x="527973" y="1571587"/>
            <a:ext cx="273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1645081" y="1341720"/>
            <a:ext cx="4924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x2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165033" y="523305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46338" y="2777935"/>
            <a:ext cx="438005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0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4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83734" y="3766883"/>
            <a:ext cx="394723" cy="1154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1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r"/>
            <a:endParaRPr lang="en-US" altLang="ko-KR" sz="9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-</a:t>
            </a:r>
          </a:p>
          <a:p>
            <a:pPr algn="r"/>
            <a:endParaRPr lang="en-US" altLang="ko-KR" sz="8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endParaRPr lang="en-US" altLang="ko-KR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197023" y="3045319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en-US" altLang="ko-KR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L-2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197023" y="3625719"/>
            <a:ext cx="761747" cy="11849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-</a:t>
            </a:r>
          </a:p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</a:p>
          <a:p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ko-KR" sz="9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</a:p>
          <a:p>
            <a:endParaRPr lang="en-US" altLang="ko-KR" sz="5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endParaRPr lang="en-US" altLang="ko-KR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5400000">
            <a:off x="3076374" y="4522582"/>
            <a:ext cx="12362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leaved </a:t>
            </a:r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-3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오른쪽 대괄호 51"/>
          <p:cNvSpPr/>
          <p:nvPr/>
        </p:nvSpPr>
        <p:spPr>
          <a:xfrm>
            <a:off x="3555149" y="4473980"/>
            <a:ext cx="45719" cy="25200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954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433</Words>
  <Application>Microsoft Office PowerPoint</Application>
  <PresentationFormat>와이드스크린</PresentationFormat>
  <Paragraphs>200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ung-Kyun Park</cp:lastModifiedBy>
  <cp:revision>5</cp:revision>
  <dcterms:created xsi:type="dcterms:W3CDTF">2021-10-12T00:46:16Z</dcterms:created>
  <dcterms:modified xsi:type="dcterms:W3CDTF">2021-10-16T06:31:38Z</dcterms:modified>
</cp:coreProperties>
</file>